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64" r:id="rId3"/>
    <p:sldId id="261" r:id="rId4"/>
    <p:sldId id="262" r:id="rId5"/>
    <p:sldId id="256" r:id="rId6"/>
    <p:sldId id="257" r:id="rId7"/>
    <p:sldId id="258" r:id="rId8"/>
    <p:sldId id="259" r:id="rId9"/>
    <p:sldId id="260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4" d="100"/>
          <a:sy n="74" d="100"/>
        </p:scale>
        <p:origin x="72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D4CCB2-5E88-A0F4-262F-C7B6303DBBF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865AC87-68F8-62A6-4A90-BA9BFD1D16E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547253-1354-5AB4-2B69-3513819843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AFBE5C-E8A6-4BBB-89D4-55FBD63BB75C}" type="datetimeFigureOut">
              <a:rPr lang="en-IN" smtClean="0"/>
              <a:t>13-03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D30D48-C64A-4680-5E82-A5BAAC7949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C5AA84-A0FC-72E0-853F-C39378DE76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55FF2-C557-4881-B502-2EC109F7EE5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489949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3D657A-D4F5-B2BC-8D5E-CAE9F1CF16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6F74045-D3E6-516A-3AB2-FA991A5C8BE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A51AC0-F750-0820-7E71-408BEBB45E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AFBE5C-E8A6-4BBB-89D4-55FBD63BB75C}" type="datetimeFigureOut">
              <a:rPr lang="en-IN" smtClean="0"/>
              <a:t>13-03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E30670-C0F3-FE2C-D77D-4643437BA0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F73C0A-5D25-5BAD-BB6B-36A6A192EF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55FF2-C557-4881-B502-2EC109F7EE5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635222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ED1DAAC-79B3-5C6C-D790-F68E4EF3870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4968A0B-E11D-6A32-2CD9-48C22794FAB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30D480-29B7-A7CA-2EEA-24402CFEA4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AFBE5C-E8A6-4BBB-89D4-55FBD63BB75C}" type="datetimeFigureOut">
              <a:rPr lang="en-IN" smtClean="0"/>
              <a:t>13-03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0E7107-6EA5-5BAC-48C9-32CA8E6D6B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D05A19-8A17-811F-23D7-35B0121A93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55FF2-C557-4881-B502-2EC109F7EE5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653240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ED9355-53DA-3281-7523-237AFA133C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B72214B-A518-2C3E-5653-847CFA4B610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E71E56-8889-3F2C-B41B-8659622A46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AFBE5C-E8A6-4BBB-89D4-55FBD63BB75C}" type="datetimeFigureOut">
              <a:rPr lang="en-IN" smtClean="0"/>
              <a:t>13-03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6B1DC4-22A9-FBC7-8E0B-CF50E191AB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87018C-DEFC-EC39-D333-239FA5E411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55FF2-C557-4881-B502-2EC109F7EE5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085286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14CBCB-03FC-1BB5-EB48-5F40258ED9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2873525-19C1-B4A1-9CEA-356BBF1AD9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8C373A-010E-DF56-6C67-A29730DC20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AFBE5C-E8A6-4BBB-89D4-55FBD63BB75C}" type="datetimeFigureOut">
              <a:rPr lang="en-IN" smtClean="0"/>
              <a:t>13-03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9FF70CF-8093-0D1C-5DEA-A5F24D190E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AC7E08-A9C4-0406-98DF-2540BBC2EC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55FF2-C557-4881-B502-2EC109F7EE5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064361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514FFD-9A6D-9C7A-5124-248F9468CB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0CFC14C-816E-7EFC-568B-EA8D5211C2E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C8038A2-EDAF-30B9-D4D8-5E154AB1892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C7A5C35-0BFA-EF33-C4FC-DC7D61297F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AFBE5C-E8A6-4BBB-89D4-55FBD63BB75C}" type="datetimeFigureOut">
              <a:rPr lang="en-IN" smtClean="0"/>
              <a:t>13-03-2023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7556C23-83BF-AFEB-B29D-8CAA777B02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B7EBF1D-FC02-11EE-F370-61CF69A79A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55FF2-C557-4881-B502-2EC109F7EE5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906513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C82A6B-92F2-6F36-1A4D-2F97EF01DF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CC31865-D546-F16F-9C87-6BB8BC8E15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BA303FA-FCD3-B600-4C9D-7EF1E77BBAD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0A386E0-75D1-0D79-3AB0-C1376646722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A669013-91E8-D3BC-D5AC-A587089F77E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5C66B9F-CCB6-A402-6D76-1E09DBEB1C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AFBE5C-E8A6-4BBB-89D4-55FBD63BB75C}" type="datetimeFigureOut">
              <a:rPr lang="en-IN" smtClean="0"/>
              <a:t>13-03-2023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2DA6A6C-FE8E-DF35-EEBE-5FB7052A20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56DB336-0792-0544-2CF5-A801B02DFD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55FF2-C557-4881-B502-2EC109F7EE5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909876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A06DDD-C8F2-E7C8-7609-187B59C5B1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3E1F35D-2800-237C-8043-7F569BC874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AFBE5C-E8A6-4BBB-89D4-55FBD63BB75C}" type="datetimeFigureOut">
              <a:rPr lang="en-IN" smtClean="0"/>
              <a:t>13-03-2023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F16F9E9-04BF-0984-DAC5-BF019825B5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A270D41-A02B-224A-96F1-8891237754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55FF2-C557-4881-B502-2EC109F7EE5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42923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384C5F7-CD69-A011-6D65-469BC5E36F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AFBE5C-E8A6-4BBB-89D4-55FBD63BB75C}" type="datetimeFigureOut">
              <a:rPr lang="en-IN" smtClean="0"/>
              <a:t>13-03-2023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F4DCD88-8791-49B9-508D-50E9257004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F0C1AF0-8985-CD42-4D38-F0AF688020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55FF2-C557-4881-B502-2EC109F7EE5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718234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3E7802-6C2E-6636-2B92-6E71036C3B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74AF02E-D71E-0354-7C8F-1C301BAEE78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88F1C42-339B-23BA-3390-EBF510D82A3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A8F75CE-5B8C-9F43-3583-E2E5AD814B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AFBE5C-E8A6-4BBB-89D4-55FBD63BB75C}" type="datetimeFigureOut">
              <a:rPr lang="en-IN" smtClean="0"/>
              <a:t>13-03-2023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D25CC2C-A66D-E094-72DF-B736E21EEB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4343F94-7A95-8A2A-B963-C634870456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55FF2-C557-4881-B502-2EC109F7EE5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766673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110A30-092F-76B1-7A72-6C83218EB3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C74735F-7C16-A80E-8679-7C30588BC38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8FC6E86-81B9-38DC-BA2D-B8365B84E3E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7197AE-F35F-8679-7BB1-012A57A615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AFBE5C-E8A6-4BBB-89D4-55FBD63BB75C}" type="datetimeFigureOut">
              <a:rPr lang="en-IN" smtClean="0"/>
              <a:t>13-03-2023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F8B006A-9027-CBCA-5682-8BA6FF7CEB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5844F9-CA9E-CB31-1A5C-21B94D186F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55FF2-C557-4881-B502-2EC109F7EE5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569039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DB0021B-E199-E80B-FAF4-74E7DAA8B1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9E152A1-E809-C52D-D009-63D7216A31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4C56EE-12E1-F011-93A0-BF600BF6DA1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AFBE5C-E8A6-4BBB-89D4-55FBD63BB75C}" type="datetimeFigureOut">
              <a:rPr lang="en-IN" smtClean="0"/>
              <a:t>13-03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24E80F-2449-7D3F-CFE8-1809527A31C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2BEF99-67B5-640F-27B6-112FDD8E037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855FF2-C557-4881-B502-2EC109F7EE5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71837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Chart, scatter chart&#10;&#10;Description automatically generated">
            <a:extLst>
              <a:ext uri="{FF2B5EF4-FFF2-40B4-BE49-F238E27FC236}">
                <a16:creationId xmlns:a16="http://schemas.microsoft.com/office/drawing/2014/main" id="{1FF03A67-899D-A0D8-672D-3AC3C90885D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51588" y="0"/>
            <a:ext cx="7344911" cy="6295638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85EE672F-AB29-CF8E-3C3B-C011A570CDD9}"/>
              </a:ext>
            </a:extLst>
          </p:cNvPr>
          <p:cNvSpPr txBox="1"/>
          <p:nvPr/>
        </p:nvSpPr>
        <p:spPr>
          <a:xfrm>
            <a:off x="2751588" y="6363159"/>
            <a:ext cx="86490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1: Baujat Plot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5874049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&#10;&#10;Description automatically generated">
            <a:extLst>
              <a:ext uri="{FF2B5EF4-FFF2-40B4-BE49-F238E27FC236}">
                <a16:creationId xmlns:a16="http://schemas.microsoft.com/office/drawing/2014/main" id="{030D2400-3325-4017-C106-8B2869175EA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67030" y="0"/>
            <a:ext cx="7529469" cy="645383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EF4059C-7B78-55B5-75C7-3CB2A50AA997}"/>
              </a:ext>
            </a:extLst>
          </p:cNvPr>
          <p:cNvSpPr txBox="1"/>
          <p:nvPr/>
        </p:nvSpPr>
        <p:spPr>
          <a:xfrm>
            <a:off x="2567030" y="6363159"/>
            <a:ext cx="86490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2: Influence Diagnostics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39093789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2AD0ECC1-3422-CA27-0827-E7FF3601982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03064" y="1392572"/>
            <a:ext cx="6055061" cy="4114144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07E7DDD7-3424-11BF-59D4-42CACBBB9F7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2456" y="1571483"/>
            <a:ext cx="5743326" cy="3902334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C2A88F73-F609-FB2E-48CB-3C4435F765AD}"/>
              </a:ext>
            </a:extLst>
          </p:cNvPr>
          <p:cNvSpPr txBox="1"/>
          <p:nvPr/>
        </p:nvSpPr>
        <p:spPr>
          <a:xfrm>
            <a:off x="385894" y="5658483"/>
            <a:ext cx="86490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3: Leave-One-Out Meta-Analysis Results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19223959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2BE2C7BF-AEFA-054A-56FF-DE4C89452CD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47900" y="422501"/>
            <a:ext cx="7696200" cy="5229225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21BBDCE0-073E-4313-7AAA-435DE41E9854}"/>
              </a:ext>
            </a:extLst>
          </p:cNvPr>
          <p:cNvSpPr txBox="1"/>
          <p:nvPr/>
        </p:nvSpPr>
        <p:spPr>
          <a:xfrm>
            <a:off x="2751588" y="6363159"/>
            <a:ext cx="86490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4a: Graphic Display of Heterogeneity (GOSH) Plot Analysis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21623795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D3FD1235-CE5A-C606-47F1-6AF5ADB599C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47900" y="814387"/>
            <a:ext cx="7696200" cy="5229225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09B52C95-5F36-7949-EC60-2B3E1147ADC4}"/>
              </a:ext>
            </a:extLst>
          </p:cNvPr>
          <p:cNvSpPr txBox="1"/>
          <p:nvPr/>
        </p:nvSpPr>
        <p:spPr>
          <a:xfrm>
            <a:off x="2751588" y="6363159"/>
            <a:ext cx="86490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4b: Graphic Display of Heterogeneity (GOSH) Plot Analysis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199197974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49DC1D00-2222-91E7-44DA-8631395C2CC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47900" y="814387"/>
            <a:ext cx="7696200" cy="522922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BBD7DBF-2A68-EA0C-1143-D971D49215D1}"/>
              </a:ext>
            </a:extLst>
          </p:cNvPr>
          <p:cNvSpPr txBox="1"/>
          <p:nvPr/>
        </p:nvSpPr>
        <p:spPr>
          <a:xfrm>
            <a:off x="2751588" y="6363159"/>
            <a:ext cx="86490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4c: Graphic Display of Heterogeneity (GOSH) Plot Analysis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308894504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5F7360F2-89CD-7140-519D-A303024E3E6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47900" y="814387"/>
            <a:ext cx="7696200" cy="5229225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D157F489-3781-6B60-A241-9683A2A8F617}"/>
              </a:ext>
            </a:extLst>
          </p:cNvPr>
          <p:cNvSpPr txBox="1"/>
          <p:nvPr/>
        </p:nvSpPr>
        <p:spPr>
          <a:xfrm>
            <a:off x="2751588" y="6363159"/>
            <a:ext cx="86490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4d: Graphic Display of Heterogeneity (GOSH) Plot Analysis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249128007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AE35ADA9-17F8-39BC-D784-9705A13AEA5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47900" y="814387"/>
            <a:ext cx="7696200" cy="5229225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094985FF-4E98-45FF-6154-92FBBEC7B2C4}"/>
              </a:ext>
            </a:extLst>
          </p:cNvPr>
          <p:cNvSpPr txBox="1"/>
          <p:nvPr/>
        </p:nvSpPr>
        <p:spPr>
          <a:xfrm>
            <a:off x="2751588" y="6363159"/>
            <a:ext cx="86490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4e: Graphic Display of Heterogeneity (GOSH) Plot Analysis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245660998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DFDD1CDD-A592-02DB-C506-48FC11F3184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47900" y="814387"/>
            <a:ext cx="7696200" cy="522922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2D43E97-FE33-6C2D-3E83-C0D2ED3FA6BF}"/>
              </a:ext>
            </a:extLst>
          </p:cNvPr>
          <p:cNvSpPr txBox="1"/>
          <p:nvPr/>
        </p:nvSpPr>
        <p:spPr>
          <a:xfrm>
            <a:off x="2751588" y="6363159"/>
            <a:ext cx="86490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4f: Graphic Display of Heterogeneity (GOSH) Plot Analysis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30987063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9</TotalTime>
  <Words>88</Words>
  <Application>Microsoft Office PowerPoint</Application>
  <PresentationFormat>Widescreen</PresentationFormat>
  <Paragraphs>9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ijaya Padhi</dc:creator>
  <cp:lastModifiedBy>MDPI</cp:lastModifiedBy>
  <cp:revision>22</cp:revision>
  <dcterms:created xsi:type="dcterms:W3CDTF">2023-03-02T16:20:50Z</dcterms:created>
  <dcterms:modified xsi:type="dcterms:W3CDTF">2023-03-13T07:24:38Z</dcterms:modified>
</cp:coreProperties>
</file>